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B947B4-CC16-4CFA-A944-9354BEDE98CB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AFDA4F-21A8-4F89-94C4-DC62EA2A4CD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615559-77EB-43E2-ADB4-CD250E9F9C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4A7D9-2815-4579-B709-8A877C70AF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2527F6-90BF-4B4C-B971-FA4A38CAF3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219191-7B49-4DE2-9FED-24D4C0C306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4BAEBE-A79D-4ACD-B5CA-978DF6E6BC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CB6C2B-D8D3-4B9A-A897-F4BC836E1B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3FB62E-74E5-4378-A357-743A817598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CB7F8-02A3-4745-B0DD-486EC781B4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48B6B-BE89-4015-A4A0-32D2665667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F90C7-98BD-4AD5-B676-0E71E74C22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E3EEA-C226-4094-874D-132BD4E4B3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B6D44-1FBB-470F-8EA6-2E4FDB8220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260DAE-F198-4AAC-96B2-19FA6059DB8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C:\Users\naito\Desktop\201407010CTnPg1 family\CTn-20140710-gray17.jpg"/>
          <p:cNvPicPr/>
          <p:nvPr/>
        </p:nvPicPr>
        <p:blipFill>
          <a:blip r:embed="rId1"/>
          <a:stretch/>
        </p:blipFill>
        <p:spPr>
          <a:xfrm>
            <a:off x="1758960" y="1763640"/>
            <a:ext cx="4910040" cy="3584520"/>
          </a:xfrm>
          <a:prstGeom prst="rect">
            <a:avLst/>
          </a:prstGeom>
          <a:ln w="0">
            <a:noFill/>
          </a:ln>
        </p:spPr>
      </p:pic>
      <p:sp>
        <p:nvSpPr>
          <p:cNvPr id="49" name="テキスト ボックス 5"/>
          <p:cNvSpPr/>
          <p:nvPr/>
        </p:nvSpPr>
        <p:spPr>
          <a:xfrm>
            <a:off x="314280" y="1763640"/>
            <a:ext cx="1962360" cy="33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re. intermedia  </a:t>
            </a: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OMA14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TnPi1-a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re. intermedia  </a:t>
            </a: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train 17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TnPi4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re. nigrescens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TCC 3356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re.buccae </a:t>
            </a: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D17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ntig 1.7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or. gingivalis 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TCC 33277 CTnPg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	</a:t>
            </a: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or. gingivalis </a:t>
            </a: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TDC6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or. endodontalis 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TCC 35406 contig 0009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Bacteroides fragili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train 638R</a:t>
            </a:r>
            <a:r>
              <a:rPr b="0" i="1" lang="en-US" sz="9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	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3"/>
          <p:cNvSpPr/>
          <p:nvPr/>
        </p:nvSpPr>
        <p:spPr>
          <a:xfrm>
            <a:off x="3047400" y="5148360"/>
            <a:ext cx="366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k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AutoShape 72"/>
          <p:cNvSpPr/>
          <p:nvPr/>
        </p:nvSpPr>
        <p:spPr>
          <a:xfrm rot="5543400">
            <a:off x="1818000" y="1729440"/>
            <a:ext cx="85680" cy="493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0240" bIns="-302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8"/>
          <p:cNvSpPr/>
          <p:nvPr/>
        </p:nvSpPr>
        <p:spPr>
          <a:xfrm>
            <a:off x="1831680" y="1636560"/>
            <a:ext cx="354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tt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AutoShape 72"/>
          <p:cNvSpPr/>
          <p:nvPr/>
        </p:nvSpPr>
        <p:spPr>
          <a:xfrm rot="5543400">
            <a:off x="5826240" y="1732680"/>
            <a:ext cx="8424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9880" bIns="-298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8"/>
          <p:cNvSpPr/>
          <p:nvPr/>
        </p:nvSpPr>
        <p:spPr>
          <a:xfrm>
            <a:off x="5869080" y="16462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tt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AutoShape 72"/>
          <p:cNvSpPr/>
          <p:nvPr/>
        </p:nvSpPr>
        <p:spPr>
          <a:xfrm rot="5543400">
            <a:off x="1991520" y="2193120"/>
            <a:ext cx="85680" cy="489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0240" bIns="-302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AutoShape 72"/>
          <p:cNvSpPr/>
          <p:nvPr/>
        </p:nvSpPr>
        <p:spPr>
          <a:xfrm rot="5543400">
            <a:off x="6473880" y="2191320"/>
            <a:ext cx="8424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9880" bIns="-298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AutoShape 72"/>
          <p:cNvSpPr/>
          <p:nvPr/>
        </p:nvSpPr>
        <p:spPr>
          <a:xfrm rot="5543400">
            <a:off x="2068920" y="2631240"/>
            <a:ext cx="86040" cy="489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0240" bIns="-302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AutoShape 72"/>
          <p:cNvSpPr/>
          <p:nvPr/>
        </p:nvSpPr>
        <p:spPr>
          <a:xfrm rot="5543400">
            <a:off x="6151680" y="2629440"/>
            <a:ext cx="8424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9880" bIns="-298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AutoShape 72"/>
          <p:cNvSpPr/>
          <p:nvPr/>
        </p:nvSpPr>
        <p:spPr>
          <a:xfrm rot="5543400">
            <a:off x="6154920" y="3062880"/>
            <a:ext cx="8424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9880" bIns="-298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AutoShape 72"/>
          <p:cNvSpPr/>
          <p:nvPr/>
        </p:nvSpPr>
        <p:spPr>
          <a:xfrm rot="5543400">
            <a:off x="2131200" y="3533040"/>
            <a:ext cx="85680" cy="489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0240" bIns="-302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AutoShape 72"/>
          <p:cNvSpPr/>
          <p:nvPr/>
        </p:nvSpPr>
        <p:spPr>
          <a:xfrm rot="5543400">
            <a:off x="5591520" y="3531240"/>
            <a:ext cx="8424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9880" bIns="-298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AutoShape 72"/>
          <p:cNvSpPr/>
          <p:nvPr/>
        </p:nvSpPr>
        <p:spPr>
          <a:xfrm rot="5543400">
            <a:off x="2089440" y="3956760"/>
            <a:ext cx="85680" cy="493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0240" bIns="-302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AutoShape 72"/>
          <p:cNvSpPr/>
          <p:nvPr/>
        </p:nvSpPr>
        <p:spPr>
          <a:xfrm rot="5543400">
            <a:off x="5831640" y="3954960"/>
            <a:ext cx="83880" cy="511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9520" bIns="-295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AutoShape 72"/>
          <p:cNvSpPr/>
          <p:nvPr/>
        </p:nvSpPr>
        <p:spPr>
          <a:xfrm rot="5543400">
            <a:off x="2038320" y="4404960"/>
            <a:ext cx="104760" cy="5400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8800" bIns="-28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AutoShape 72"/>
          <p:cNvSpPr/>
          <p:nvPr/>
        </p:nvSpPr>
        <p:spPr>
          <a:xfrm rot="5543400">
            <a:off x="6004080" y="4390200"/>
            <a:ext cx="8424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9880" bIns="-298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AutoShape 72"/>
          <p:cNvSpPr/>
          <p:nvPr/>
        </p:nvSpPr>
        <p:spPr>
          <a:xfrm rot="5543400">
            <a:off x="2123280" y="4818960"/>
            <a:ext cx="85680" cy="489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0240" bIns="-302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AutoShape 72"/>
          <p:cNvSpPr/>
          <p:nvPr/>
        </p:nvSpPr>
        <p:spPr>
          <a:xfrm rot="5543400">
            <a:off x="6353280" y="4817160"/>
            <a:ext cx="8424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9880" bIns="-298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直線コネクタ 2"/>
          <p:cNvSpPr/>
          <p:nvPr/>
        </p:nvSpPr>
        <p:spPr>
          <a:xfrm>
            <a:off x="4149720" y="2932200"/>
            <a:ext cx="1008000" cy="0"/>
          </a:xfrm>
          <a:prstGeom prst="line">
            <a:avLst/>
          </a:prstGeom>
          <a:ln w="381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直線コネクタ 106"/>
          <p:cNvSpPr/>
          <p:nvPr/>
        </p:nvSpPr>
        <p:spPr>
          <a:xfrm>
            <a:off x="4148280" y="3360600"/>
            <a:ext cx="1009440" cy="0"/>
          </a:xfrm>
          <a:prstGeom prst="line">
            <a:avLst/>
          </a:prstGeom>
          <a:ln w="381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直線コネクタ 107"/>
          <p:cNvSpPr/>
          <p:nvPr/>
        </p:nvSpPr>
        <p:spPr>
          <a:xfrm>
            <a:off x="4638600" y="2484360"/>
            <a:ext cx="833400" cy="0"/>
          </a:xfrm>
          <a:prstGeom prst="line">
            <a:avLst/>
          </a:prstGeom>
          <a:ln w="381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直線コネクタ 108"/>
          <p:cNvSpPr/>
          <p:nvPr/>
        </p:nvSpPr>
        <p:spPr>
          <a:xfrm>
            <a:off x="4146480" y="2482920"/>
            <a:ext cx="69840" cy="0"/>
          </a:xfrm>
          <a:prstGeom prst="line">
            <a:avLst/>
          </a:prstGeom>
          <a:ln w="381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直線コネクタ 109"/>
          <p:cNvSpPr/>
          <p:nvPr/>
        </p:nvSpPr>
        <p:spPr>
          <a:xfrm>
            <a:off x="4170240" y="2060640"/>
            <a:ext cx="219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直線コネクタ 110"/>
          <p:cNvSpPr/>
          <p:nvPr/>
        </p:nvSpPr>
        <p:spPr>
          <a:xfrm>
            <a:off x="4154400" y="4237200"/>
            <a:ext cx="219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直線コネクタ 111"/>
          <p:cNvSpPr/>
          <p:nvPr/>
        </p:nvSpPr>
        <p:spPr>
          <a:xfrm>
            <a:off x="4160880" y="4672080"/>
            <a:ext cx="2188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直線コネクタ 112"/>
          <p:cNvSpPr/>
          <p:nvPr/>
        </p:nvSpPr>
        <p:spPr>
          <a:xfrm>
            <a:off x="4653000" y="4672080"/>
            <a:ext cx="165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直線コネクタ 113"/>
          <p:cNvSpPr/>
          <p:nvPr/>
        </p:nvSpPr>
        <p:spPr>
          <a:xfrm>
            <a:off x="4683240" y="2058840"/>
            <a:ext cx="1490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テキスト ボックス 3"/>
          <p:cNvSpPr/>
          <p:nvPr/>
        </p:nvSpPr>
        <p:spPr>
          <a:xfrm rot="19200000">
            <a:off x="1906560" y="1187280"/>
            <a:ext cx="82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nti-restrictio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rote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テキスト ボックス 4"/>
          <p:cNvSpPr/>
          <p:nvPr/>
        </p:nvSpPr>
        <p:spPr>
          <a:xfrm>
            <a:off x="2376360" y="1541520"/>
            <a:ext cx="141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          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ra gen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QPONMLKJI GEF     A    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テキスト ボックス 114"/>
          <p:cNvSpPr/>
          <p:nvPr/>
        </p:nvSpPr>
        <p:spPr>
          <a:xfrm rot="19200000">
            <a:off x="5573520" y="1410840"/>
            <a:ext cx="61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integras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テキスト ボックス 115"/>
          <p:cNvSpPr/>
          <p:nvPr/>
        </p:nvSpPr>
        <p:spPr>
          <a:xfrm rot="19200000">
            <a:off x="3774600" y="1365120"/>
            <a:ext cx="908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upling protein T4C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テキスト ボックス 116"/>
          <p:cNvSpPr/>
          <p:nvPr/>
        </p:nvSpPr>
        <p:spPr>
          <a:xfrm rot="19200000">
            <a:off x="4739040" y="1295280"/>
            <a:ext cx="993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NA topoisomerase I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テキスト ボックス 117"/>
          <p:cNvSpPr/>
          <p:nvPr/>
        </p:nvSpPr>
        <p:spPr>
          <a:xfrm rot="19200000">
            <a:off x="5160600" y="1378080"/>
            <a:ext cx="719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NA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ethylas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テキスト ボックス 118"/>
          <p:cNvSpPr/>
          <p:nvPr/>
        </p:nvSpPr>
        <p:spPr>
          <a:xfrm rot="19200000">
            <a:off x="2276280" y="1338120"/>
            <a:ext cx="60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ysozym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39"/>
          <p:cNvSpPr/>
          <p:nvPr/>
        </p:nvSpPr>
        <p:spPr>
          <a:xfrm>
            <a:off x="356760" y="68436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テキスト ボックス 115"/>
          <p:cNvSpPr/>
          <p:nvPr/>
        </p:nvSpPr>
        <p:spPr>
          <a:xfrm rot="19200000">
            <a:off x="3630240" y="134136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elaxas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3T01:33:32Z</dcterms:created>
  <dc:creator>naito</dc:creator>
  <dc:description/>
  <dc:language>en-US</dc:language>
  <cp:lastModifiedBy>naito</cp:lastModifiedBy>
  <dcterms:modified xsi:type="dcterms:W3CDTF">2015-09-25T01:11:18Z</dcterms:modified>
  <cp:revision>2</cp:revision>
  <dc:subject/>
  <dc:title>PowerPoint プレゼンテーション</dc:title>
</cp:coreProperties>
</file>